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9" r:id="rId4"/>
    <p:sldId id="258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32" autoAdjust="0"/>
    <p:restoredTop sz="94660"/>
  </p:normalViewPr>
  <p:slideViewPr>
    <p:cSldViewPr snapToGrid="0">
      <p:cViewPr varScale="1">
        <p:scale>
          <a:sx n="64" d="100"/>
          <a:sy n="64" d="100"/>
        </p:scale>
        <p:origin x="90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23603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4799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386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6592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0227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3126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64811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7273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5567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6139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04889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A56CC7-1023-465F-98DF-F3A3BE90E383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8C19E4-FA9D-4F3D-8929-3D89A4E0802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5651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ttangolo 9"/>
          <p:cNvSpPr/>
          <p:nvPr/>
        </p:nvSpPr>
        <p:spPr>
          <a:xfrm>
            <a:off x="5752042" y="1362364"/>
            <a:ext cx="518092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A</a:t>
            </a:r>
            <a:endParaRPr lang="it-IT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ttangolo 10"/>
          <p:cNvSpPr/>
          <p:nvPr/>
        </p:nvSpPr>
        <p:spPr>
          <a:xfrm>
            <a:off x="573786" y="308832"/>
            <a:ext cx="110871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grams with normal distribution curves A) for osmotic adjustment (OA), B) for osmotic potential under full and deficit irrigation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ψ</a:t>
            </a:r>
            <a:r>
              <a:rPr lang="en-US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ψ</a:t>
            </a:r>
            <a:r>
              <a:rPr lang="en-US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), C) for relative water content under full and deficit irrigation (RWC-c and RWC-s) and D) for leaf rolling (LR) and chlorophyll content (SPAD). 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Immagine 14"/>
          <p:cNvPicPr>
            <a:picLocks noChangeAspect="1"/>
          </p:cNvPicPr>
          <p:nvPr/>
        </p:nvPicPr>
        <p:blipFill rotWithShape="1">
          <a:blip r:embed="rId2"/>
          <a:srcRect t="14123"/>
          <a:stretch/>
        </p:blipFill>
        <p:spPr>
          <a:xfrm>
            <a:off x="3421102" y="1895475"/>
            <a:ext cx="5179973" cy="4448412"/>
          </a:xfrm>
          <a:prstGeom prst="rect">
            <a:avLst/>
          </a:prstGeom>
        </p:spPr>
      </p:pic>
      <p:sp>
        <p:nvSpPr>
          <p:cNvPr id="16" name="Rettangolo 15"/>
          <p:cNvSpPr/>
          <p:nvPr/>
        </p:nvSpPr>
        <p:spPr>
          <a:xfrm>
            <a:off x="3421102" y="1208476"/>
            <a:ext cx="444352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sz="7200" b="1" cap="none" spc="0" dirty="0">
              <a:ln w="0"/>
              <a:solidFill>
                <a:srgbClr val="C0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75485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2"/>
          <a:srcRect t="14082"/>
          <a:stretch/>
        </p:blipFill>
        <p:spPr>
          <a:xfrm>
            <a:off x="6086476" y="1352550"/>
            <a:ext cx="6019800" cy="5172076"/>
          </a:xfrm>
          <a:prstGeom prst="rect">
            <a:avLst/>
          </a:prstGeom>
        </p:spPr>
      </p:pic>
      <p:sp>
        <p:nvSpPr>
          <p:cNvPr id="4" name="Rettangolo 3"/>
          <p:cNvSpPr/>
          <p:nvPr/>
        </p:nvSpPr>
        <p:spPr>
          <a:xfrm>
            <a:off x="3123372" y="904339"/>
            <a:ext cx="877228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WC-c</a:t>
            </a:r>
            <a:endParaRPr lang="it-IT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ttangolo 4"/>
          <p:cNvSpPr/>
          <p:nvPr/>
        </p:nvSpPr>
        <p:spPr>
          <a:xfrm>
            <a:off x="8978134" y="904339"/>
            <a:ext cx="864404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WC-s</a:t>
            </a:r>
            <a:endParaRPr lang="it-IT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ttangolo 5"/>
          <p:cNvSpPr/>
          <p:nvPr/>
        </p:nvSpPr>
        <p:spPr>
          <a:xfrm>
            <a:off x="835749" y="601058"/>
            <a:ext cx="42351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it-IT" sz="7200" b="1" cap="none" spc="0" dirty="0">
              <a:ln w="0"/>
              <a:solidFill>
                <a:srgbClr val="C0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3"/>
          <a:srcRect l="9042" t="7601" r="9980" b="7467"/>
          <a:stretch/>
        </p:blipFill>
        <p:spPr>
          <a:xfrm>
            <a:off x="802423" y="1302246"/>
            <a:ext cx="4979252" cy="52223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30763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2"/>
          <a:srcRect t="13979"/>
          <a:stretch/>
        </p:blipFill>
        <p:spPr>
          <a:xfrm>
            <a:off x="161925" y="1438275"/>
            <a:ext cx="6200776" cy="5334000"/>
          </a:xfrm>
          <a:prstGeom prst="rect">
            <a:avLst/>
          </a:prstGeom>
        </p:spPr>
      </p:pic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3"/>
          <a:srcRect t="14308"/>
          <a:stretch/>
        </p:blipFill>
        <p:spPr>
          <a:xfrm>
            <a:off x="6134100" y="1381125"/>
            <a:ext cx="6124575" cy="5248274"/>
          </a:xfrm>
          <a:prstGeom prst="rect">
            <a:avLst/>
          </a:prstGeom>
        </p:spPr>
      </p:pic>
      <p:sp>
        <p:nvSpPr>
          <p:cNvPr id="4" name="Rettangolo 3"/>
          <p:cNvSpPr/>
          <p:nvPr/>
        </p:nvSpPr>
        <p:spPr>
          <a:xfrm>
            <a:off x="9196387" y="941986"/>
            <a:ext cx="580608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Ψ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</a:t>
            </a:r>
            <a:endParaRPr lang="it-IT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ttangolo 4"/>
          <p:cNvSpPr/>
          <p:nvPr/>
        </p:nvSpPr>
        <p:spPr>
          <a:xfrm>
            <a:off x="2965597" y="941986"/>
            <a:ext cx="593432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Ψ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</a:t>
            </a:r>
            <a:endParaRPr lang="it-IT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ttangolo 5"/>
          <p:cNvSpPr/>
          <p:nvPr/>
        </p:nvSpPr>
        <p:spPr>
          <a:xfrm>
            <a:off x="825330" y="624870"/>
            <a:ext cx="444352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7200" b="1" cap="none" spc="0" dirty="0">
              <a:ln w="0"/>
              <a:solidFill>
                <a:srgbClr val="C0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25376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2"/>
          <a:srcRect t="13735"/>
          <a:stretch/>
        </p:blipFill>
        <p:spPr>
          <a:xfrm>
            <a:off x="17302" y="1162050"/>
            <a:ext cx="6116798" cy="5276624"/>
          </a:xfrm>
          <a:prstGeom prst="rect">
            <a:avLst/>
          </a:prstGeom>
        </p:spPr>
      </p:pic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3"/>
          <a:srcRect t="13759"/>
          <a:stretch/>
        </p:blipFill>
        <p:spPr>
          <a:xfrm>
            <a:off x="6049831" y="1152524"/>
            <a:ext cx="6037394" cy="5206745"/>
          </a:xfrm>
          <a:prstGeom prst="rect">
            <a:avLst/>
          </a:prstGeom>
        </p:spPr>
      </p:pic>
      <p:sp>
        <p:nvSpPr>
          <p:cNvPr id="4" name="Rettangolo 3"/>
          <p:cNvSpPr/>
          <p:nvPr/>
        </p:nvSpPr>
        <p:spPr>
          <a:xfrm>
            <a:off x="2835892" y="783192"/>
            <a:ext cx="479619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endParaRPr lang="it-IT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ttangolo 4"/>
          <p:cNvSpPr/>
          <p:nvPr/>
        </p:nvSpPr>
        <p:spPr>
          <a:xfrm>
            <a:off x="8884817" y="808076"/>
            <a:ext cx="753411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AD</a:t>
            </a:r>
            <a:endParaRPr lang="it-IT" sz="54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ttangolo 5"/>
          <p:cNvSpPr/>
          <p:nvPr/>
        </p:nvSpPr>
        <p:spPr>
          <a:xfrm>
            <a:off x="751871" y="372457"/>
            <a:ext cx="444352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28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it-IT" sz="7200" b="1" cap="none" spc="0" dirty="0">
              <a:ln w="0"/>
              <a:solidFill>
                <a:srgbClr val="C0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50091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75</Words>
  <Application>Microsoft Office PowerPoint</Application>
  <PresentationFormat>Widescreen</PresentationFormat>
  <Paragraphs>1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ema di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Emanuele Condorelli</dc:creator>
  <cp:lastModifiedBy>Giuseppe CONDORELLI</cp:lastModifiedBy>
  <cp:revision>14</cp:revision>
  <dcterms:created xsi:type="dcterms:W3CDTF">2018-07-26T09:59:57Z</dcterms:created>
  <dcterms:modified xsi:type="dcterms:W3CDTF">2021-12-10T16:38:18Z</dcterms:modified>
</cp:coreProperties>
</file>